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5" autoAdjust="0"/>
    <p:restoredTop sz="94660"/>
  </p:normalViewPr>
  <p:slideViewPr>
    <p:cSldViewPr snapToGrid="0">
      <p:cViewPr varScale="1">
        <p:scale>
          <a:sx n="80" d="100"/>
          <a:sy n="80" d="100"/>
        </p:scale>
        <p:origin x="105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25552-6066-4CC9-B4A5-F69A9D7C841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B8AB1B-6931-42BD-8256-6EBBA606E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652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25552-6066-4CC9-B4A5-F69A9D7C841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B8AB1B-6931-42BD-8256-6EBBA606E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677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25552-6066-4CC9-B4A5-F69A9D7C841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B8AB1B-6931-42BD-8256-6EBBA606E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2085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25552-6066-4CC9-B4A5-F69A9D7C841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B8AB1B-6931-42BD-8256-6EBBA606E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0719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25552-6066-4CC9-B4A5-F69A9D7C841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B8AB1B-6931-42BD-8256-6EBBA606E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8077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25552-6066-4CC9-B4A5-F69A9D7C841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B8AB1B-6931-42BD-8256-6EBBA606E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8387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25552-6066-4CC9-B4A5-F69A9D7C841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B8AB1B-6931-42BD-8256-6EBBA606E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506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25552-6066-4CC9-B4A5-F69A9D7C841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B8AB1B-6931-42BD-8256-6EBBA606E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5199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25552-6066-4CC9-B4A5-F69A9D7C841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B8AB1B-6931-42BD-8256-6EBBA606E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329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25552-6066-4CC9-B4A5-F69A9D7C841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B8AB1B-6931-42BD-8256-6EBBA606E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674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25552-6066-4CC9-B4A5-F69A9D7C841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B8AB1B-6931-42BD-8256-6EBBA606E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3446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B25552-6066-4CC9-B4A5-F69A9D7C841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B8AB1B-6931-42BD-8256-6EBBA606E6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6369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143000" y="888802"/>
            <a:ext cx="2404533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 smtClean="0"/>
              <a:t>Figure </a:t>
            </a:r>
            <a:r>
              <a:rPr lang="en-US" sz="1350" dirty="0" smtClean="0"/>
              <a:t>S1</a:t>
            </a:r>
            <a:r>
              <a:rPr lang="en-US" sz="1350" dirty="0" smtClean="0"/>
              <a:t>.</a:t>
            </a:r>
            <a:endParaRPr lang="en-US" sz="1350" dirty="0"/>
          </a:p>
        </p:txBody>
      </p:sp>
      <p:sp>
        <p:nvSpPr>
          <p:cNvPr id="7" name="TextBox 6"/>
          <p:cNvSpPr txBox="1"/>
          <p:nvPr/>
        </p:nvSpPr>
        <p:spPr>
          <a:xfrm>
            <a:off x="1605669" y="3820501"/>
            <a:ext cx="590915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 smtClean="0"/>
              <a:t>Figure </a:t>
            </a:r>
            <a:r>
              <a:rPr lang="en-US" sz="1200" dirty="0" smtClean="0"/>
              <a:t>S1</a:t>
            </a:r>
            <a:r>
              <a:rPr lang="en-US" sz="1200" dirty="0" smtClean="0"/>
              <a:t>. </a:t>
            </a:r>
            <a:r>
              <a:rPr lang="en-US" sz="1200" dirty="0"/>
              <a:t>Increased pigmentation during nitrogen starvation. </a:t>
            </a:r>
            <a:r>
              <a:rPr lang="en-US" sz="1200" i="1" dirty="0"/>
              <a:t>M. </a:t>
            </a:r>
            <a:r>
              <a:rPr lang="en-US" sz="1200" i="1" dirty="0" err="1"/>
              <a:t>oryzae</a:t>
            </a:r>
            <a:r>
              <a:rPr lang="en-US" sz="1200" dirty="0"/>
              <a:t> strain 70-15 spores were harvested from 1 week old V8 agar plates and inoculated into complete liquid medium.  The culture was grown at 28 °C for 3 days. The mycelial mat was then collected, washed, with distilled water and was placed into a flask containing minimal media supplemented with nitrogen (N+) or without nitrogen source (N-). The cultures were grown at 28 °C for 12h and mycelia harvested before the photograph was taken.</a:t>
            </a:r>
          </a:p>
        </p:txBody>
      </p:sp>
      <p:pic>
        <p:nvPicPr>
          <p:cNvPr id="3" name="Picture 2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852515" y="1778757"/>
            <a:ext cx="1714500" cy="1714500"/>
          </a:xfrm>
          <a:prstGeom prst="rect">
            <a:avLst/>
          </a:prstGeom>
        </p:spPr>
      </p:pic>
      <p:pic>
        <p:nvPicPr>
          <p:cNvPr id="4" name="Picture 3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4567015" y="1778757"/>
            <a:ext cx="1714500" cy="171450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2908535" y="1837826"/>
            <a:ext cx="337298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/>
              <a:t>                N+                                       N-</a:t>
            </a:r>
          </a:p>
        </p:txBody>
      </p:sp>
      <p:sp>
        <p:nvSpPr>
          <p:cNvPr id="5" name="Rectangle 4"/>
          <p:cNvSpPr/>
          <p:nvPr/>
        </p:nvSpPr>
        <p:spPr>
          <a:xfrm>
            <a:off x="2814880" y="3439661"/>
            <a:ext cx="3546891" cy="2109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</p:spTree>
    <p:extLst>
      <p:ext uri="{BB962C8B-B14F-4D97-AF65-F5344CB8AC3E}">
        <p14:creationId xmlns:p14="http://schemas.microsoft.com/office/powerpoint/2010/main" val="2685641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96</TotalTime>
  <Words>19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hfulvia70</dc:creator>
  <cp:lastModifiedBy>ohfulvia70</cp:lastModifiedBy>
  <cp:revision>4</cp:revision>
  <dcterms:created xsi:type="dcterms:W3CDTF">2017-03-30T16:29:54Z</dcterms:created>
  <dcterms:modified xsi:type="dcterms:W3CDTF">2017-05-11T16:56:12Z</dcterms:modified>
</cp:coreProperties>
</file>